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ED7974-67A3-4907-9FED-3F1038ECB8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00398B-4198-41EE-86FA-4231662121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FD2E6-84E5-40C1-96A4-69F8770AAA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D672D-1CF6-4CDA-AB6B-4DC83711BE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A7668-6605-4251-A784-F46646E613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F24B1A-C980-4CBA-8446-22DFC4DDF8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BFC95-81BD-4DE5-8118-B8E92E8E7A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E3B2E-F739-4BD1-93EC-4C1BE3DD47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DD7661-D5AA-4D1F-9486-F210545043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877E30-66DE-4A2E-92AA-550E21A8B2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3502C-B689-4650-905E-BC83FBD22A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9D11C-1E22-4409-A758-82AD1F991A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E0C428-7642-457F-9AA6-BC03717C60DC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85BDA8-639E-40A4-A0D2-5DA2670CB78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4" descr=""/>
          <p:cNvPicPr/>
          <p:nvPr/>
        </p:nvPicPr>
        <p:blipFill>
          <a:blip r:embed="rId1"/>
          <a:stretch/>
        </p:blipFill>
        <p:spPr>
          <a:xfrm>
            <a:off x="2227320" y="2335320"/>
            <a:ext cx="1871640" cy="323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図 5" descr=""/>
          <p:cNvPicPr/>
          <p:nvPr/>
        </p:nvPicPr>
        <p:blipFill>
          <a:blip r:embed="rId2"/>
          <a:stretch/>
        </p:blipFill>
        <p:spPr>
          <a:xfrm>
            <a:off x="2228760" y="2693880"/>
            <a:ext cx="1871640" cy="144720"/>
          </a:xfrm>
          <a:prstGeom prst="rect">
            <a:avLst/>
          </a:prstGeom>
          <a:ln w="0">
            <a:noFill/>
          </a:ln>
        </p:spPr>
      </p:pic>
      <p:sp>
        <p:nvSpPr>
          <p:cNvPr id="43" name="正方形/長方形 151"/>
          <p:cNvSpPr/>
          <p:nvPr/>
        </p:nvSpPr>
        <p:spPr>
          <a:xfrm>
            <a:off x="2220840" y="2690640"/>
            <a:ext cx="1905120" cy="158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12600" dir="5400000" blurRad="0" rotWithShape="0">
              <a:srgbClr val="808080"/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直線コネクタ 152"/>
          <p:cNvSpPr/>
          <p:nvPr/>
        </p:nvSpPr>
        <p:spPr>
          <a:xfrm>
            <a:off x="3354480" y="2154240"/>
            <a:ext cx="3585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2540160" y="2108160"/>
            <a:ext cx="338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6"/>
          <p:cNvSpPr/>
          <p:nvPr/>
        </p:nvSpPr>
        <p:spPr>
          <a:xfrm>
            <a:off x="2357280" y="2108160"/>
            <a:ext cx="30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6"/>
          <p:cNvSpPr/>
          <p:nvPr/>
        </p:nvSpPr>
        <p:spPr>
          <a:xfrm>
            <a:off x="2730600" y="2108160"/>
            <a:ext cx="43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6"/>
          <p:cNvSpPr/>
          <p:nvPr/>
        </p:nvSpPr>
        <p:spPr>
          <a:xfrm>
            <a:off x="3294000" y="2108160"/>
            <a:ext cx="43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6"/>
          <p:cNvSpPr/>
          <p:nvPr/>
        </p:nvSpPr>
        <p:spPr>
          <a:xfrm>
            <a:off x="3287880" y="1928880"/>
            <a:ext cx="69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NF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60"/>
          <p:cNvSpPr/>
          <p:nvPr/>
        </p:nvSpPr>
        <p:spPr>
          <a:xfrm>
            <a:off x="3098880" y="2109960"/>
            <a:ext cx="25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60"/>
          <p:cNvSpPr/>
          <p:nvPr/>
        </p:nvSpPr>
        <p:spPr>
          <a:xfrm>
            <a:off x="3487680" y="2108160"/>
            <a:ext cx="38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正方形/長方形 160"/>
          <p:cNvGrpSpPr/>
          <p:nvPr/>
        </p:nvGrpSpPr>
        <p:grpSpPr>
          <a:xfrm>
            <a:off x="3736800" y="2322360"/>
            <a:ext cx="536400" cy="543240"/>
            <a:chOff x="3736800" y="2322360"/>
            <a:chExt cx="536400" cy="543240"/>
          </a:xfrm>
        </p:grpSpPr>
        <p:pic>
          <p:nvPicPr>
            <p:cNvPr id="53" name="正方形/長方形 160" descr=""/>
            <p:cNvPicPr/>
            <p:nvPr/>
          </p:nvPicPr>
          <p:blipFill>
            <a:blip r:embed="rId3"/>
            <a:stretch/>
          </p:blipFill>
          <p:spPr>
            <a:xfrm>
              <a:off x="3737880" y="2322360"/>
              <a:ext cx="535320" cy="543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"/>
            <p:cNvSpPr/>
            <p:nvPr/>
          </p:nvSpPr>
          <p:spPr>
            <a:xfrm>
              <a:off x="3736800" y="2325600"/>
              <a:ext cx="530280" cy="53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直線コネクタ 161"/>
          <p:cNvSpPr/>
          <p:nvPr/>
        </p:nvSpPr>
        <p:spPr>
          <a:xfrm flipH="1">
            <a:off x="3731760" y="2328840"/>
            <a:ext cx="1800" cy="335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直線コネクタ 162"/>
          <p:cNvSpPr/>
          <p:nvPr/>
        </p:nvSpPr>
        <p:spPr>
          <a:xfrm flipH="1">
            <a:off x="3730680" y="2690640"/>
            <a:ext cx="1440" cy="162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二等辺三角形 208"/>
          <p:cNvSpPr/>
          <p:nvPr/>
        </p:nvSpPr>
        <p:spPr>
          <a:xfrm flipH="1" rot="16200000">
            <a:off x="3863520" y="2427840"/>
            <a:ext cx="69840" cy="1443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t" anchorCtr="1" vert="eaVer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6"/>
          <p:cNvSpPr/>
          <p:nvPr/>
        </p:nvSpPr>
        <p:spPr>
          <a:xfrm>
            <a:off x="2133720" y="2106720"/>
            <a:ext cx="43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23"/>
          <p:cNvSpPr/>
          <p:nvPr/>
        </p:nvSpPr>
        <p:spPr>
          <a:xfrm>
            <a:off x="2360520" y="2797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23"/>
          <p:cNvSpPr/>
          <p:nvPr/>
        </p:nvSpPr>
        <p:spPr>
          <a:xfrm>
            <a:off x="2552760" y="2797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23"/>
          <p:cNvSpPr/>
          <p:nvPr/>
        </p:nvSpPr>
        <p:spPr>
          <a:xfrm>
            <a:off x="2751120" y="2797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23"/>
          <p:cNvSpPr/>
          <p:nvPr/>
        </p:nvSpPr>
        <p:spPr>
          <a:xfrm>
            <a:off x="2925720" y="2797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23"/>
          <p:cNvSpPr/>
          <p:nvPr/>
        </p:nvSpPr>
        <p:spPr>
          <a:xfrm>
            <a:off x="3129120" y="2797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23"/>
          <p:cNvSpPr/>
          <p:nvPr/>
        </p:nvSpPr>
        <p:spPr>
          <a:xfrm>
            <a:off x="3317760" y="2797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23"/>
          <p:cNvSpPr/>
          <p:nvPr/>
        </p:nvSpPr>
        <p:spPr>
          <a:xfrm>
            <a:off x="3505320" y="2797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6"/>
          <p:cNvSpPr/>
          <p:nvPr/>
        </p:nvSpPr>
        <p:spPr>
          <a:xfrm>
            <a:off x="2913120" y="2109960"/>
            <a:ext cx="43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56"/>
          <p:cNvSpPr/>
          <p:nvPr/>
        </p:nvSpPr>
        <p:spPr>
          <a:xfrm>
            <a:off x="3662280" y="2614680"/>
            <a:ext cx="69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174"/>
          <p:cNvSpPr/>
          <p:nvPr/>
        </p:nvSpPr>
        <p:spPr>
          <a:xfrm>
            <a:off x="421560" y="438120"/>
            <a:ext cx="2623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ary Figure S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正方形/長方形 71"/>
          <p:cNvSpPr/>
          <p:nvPr/>
        </p:nvSpPr>
        <p:spPr>
          <a:xfrm>
            <a:off x="380880" y="3733920"/>
            <a:ext cx="61722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7. Effects of MNF on rVpr-induced L1-RTP. U, untreated; D, DMSO; B, buffer; M, MNF; V, rVpr. Arrowhead indicates the 140-bp band generated by induction of L1-RTP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51:47Z</dcterms:modified>
  <cp:revision>1632</cp:revision>
  <dc:subject/>
  <dc:title>スライド 1</dc:title>
</cp:coreProperties>
</file>